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854DF5-1E15-4764-BD87-55538C828F6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1AE2D3-8923-4B9F-B90C-1B660D7E19C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C0599-F8D0-4C5C-A336-DDC413D9D2E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A76B9-3696-496F-B695-66F7C154B52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EC5A4-3A67-4E04-97F1-FC7E6529BE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B51F7-8EF0-4478-B777-8B5E4890D0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5A7AF-44D9-4935-ACC0-D2527289A44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BE569-F2F5-4642-BBA6-1544075663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F47057-4E53-451D-9D74-7B76B44294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94CA0F-A489-4BAF-972F-E6214B172FF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F1DB23-0AE7-413B-9AD9-BBB857DAFA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7FC1E-AD6C-4BD2-B44D-A9DF66CC56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382468E-D4C8-4FB2-B31A-C730D2144A4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981080" y="912960"/>
          <a:ext cx="5289840" cy="365580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981080" y="912960"/>
                    <a:ext cx="5289840" cy="3655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3" name=""/>
          <p:cNvSpPr/>
          <p:nvPr/>
        </p:nvSpPr>
        <p:spPr>
          <a:xfrm>
            <a:off x="6160680" y="6553080"/>
            <a:ext cx="185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ileti et al. Figure S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447920" y="5029200"/>
            <a:ext cx="7010280" cy="1919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3. L. paracasei induces increased levels of TSL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aco-2 cells were grown as monolayers in the upper chamber of a transwell filter and incubated with bacteria (5x10</a:t>
            </a:r>
            <a:r>
              <a:rPr b="0" lang="en-US" sz="1200" spc="-1" strike="noStrike" baseline="30000">
                <a:solidFill>
                  <a:srgbClr val="000000"/>
                </a:solidFill>
                <a:latin typeface="Arial"/>
              </a:rPr>
              <a:t>7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CFU/TW) from the apical surface (top chamber). One hour after incubation, bacteria were washed out and medium was changed with one containing antibiotics (gentamycin 100 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/mL). Cells were collected 3, 5, 23 and 48 hours later from the bottom chamber. mRNA was isolated and retrotranscribed. Quantitative RT-PCR showing TSLP mRNA expression levels normalized to TBP gene are shown. The bars represent normalized TSLP expression values (TSLP/TBP ratios). One of two independent experiments is show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8-17T11:41:30Z</dcterms:created>
  <dc:creator>Comp.Dept. IFOM</dc:creator>
  <dc:description/>
  <dc:language>en-US</dc:language>
  <cp:lastModifiedBy>Comp.Dept. IFOM</cp:lastModifiedBy>
  <dcterms:modified xsi:type="dcterms:W3CDTF">2009-08-17T16:04:56Z</dcterms:modified>
  <cp:revision>2</cp:revision>
  <dc:subject/>
  <dc:title>PowerPoint Presentation</dc:title>
</cp:coreProperties>
</file>